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9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299;&#26512;\&#27700;&#37326;\FN_&#27700;&#37326;\20250512_&#26619;&#35501;&#24460;&#12420;&#12426;&#30452;&#12375;\PS&#12510;&#12483;&#12481;&#24460;3906&#21517;_&#26368;&#32066;&#25505;&#2999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元データ_ピボット!$AM$10</c:f>
              <c:strCache>
                <c:ptCount val="1"/>
                <c:pt idx="0">
                  <c:v>28日死亡率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元データ_ピボット!$AN$9:$AO$9</c:f>
              <c:strCache>
                <c:ptCount val="2"/>
                <c:pt idx="0">
                  <c:v>Guideline adherence group</c:v>
                </c:pt>
                <c:pt idx="1">
                  <c:v>Non-guideline adherence group</c:v>
                </c:pt>
              </c:strCache>
            </c:strRef>
          </c:cat>
          <c:val>
            <c:numRef>
              <c:f>元データ_ピボット!$AN$10:$AO$10</c:f>
              <c:numCache>
                <c:formatCode>0.0</c:formatCode>
                <c:ptCount val="2"/>
                <c:pt idx="0">
                  <c:v>5.7859703020993347</c:v>
                </c:pt>
                <c:pt idx="1">
                  <c:v>8.5509472606246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38-4F8A-9E38-3E2D49DE65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3177984"/>
        <c:axId val="2083181312"/>
      </c:barChart>
      <c:catAx>
        <c:axId val="2083177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ja-JP"/>
          </a:p>
        </c:txPr>
        <c:crossAx val="2083181312"/>
        <c:crosses val="autoZero"/>
        <c:auto val="1"/>
        <c:lblAlgn val="ctr"/>
        <c:lblOffset val="100"/>
        <c:noMultiLvlLbl val="0"/>
      </c:catAx>
      <c:valAx>
        <c:axId val="2083181312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 altLang="ja-JP" sz="1200" baseline="0">
                    <a:solidFill>
                      <a:schemeClr val="tx1"/>
                    </a:solidFill>
                    <a:latin typeface="Times New Roman" panose="02020603050405020304" pitchFamily="18" charset="0"/>
                  </a:rPr>
                  <a:t>28-day mortality rate</a:t>
                </a:r>
                <a:endParaRPr lang="ja-JP" altLang="en-US" sz="1200" baseline="0">
                  <a:solidFill>
                    <a:schemeClr val="tx1"/>
                  </a:solidFill>
                  <a:latin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ja-JP"/>
            </a:p>
          </c:txPr>
        </c:title>
        <c:numFmt formatCode="0.0" sourceLinked="0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ja-JP"/>
          </a:p>
        </c:txPr>
        <c:crossAx val="2083177984"/>
        <c:crosses val="autoZero"/>
        <c:crossBetween val="between"/>
        <c:majorUnit val="5"/>
        <c:min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B6CC5E-F0FA-45B6-A5BD-A6F091C572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447C2A6-39A5-485A-B2B6-A0C9A460BF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B4B63C-A9D0-4BBD-8082-178D96EAA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0B92BB-5E7D-444B-8AE2-E920D7F40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50C5347-4E89-477F-87A3-20D31FC87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435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EF9B03-A885-4EE6-BE94-8F208254EF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4BF0797-38ED-479C-8BA5-19EF2F95A2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975632-2D5C-45B4-AFC7-86E9D6F6F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86FE6C-6B9C-402C-A01A-68D03D11A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67DF56-FAEA-4C12-90BE-759163ADC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2373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1148570-946C-4B91-9885-7C5C65931B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8845808-9EA6-4142-9C5E-A0B5F8556D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FB409A-AA98-4BA3-A5EC-2A4D01605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84A7E0-97E3-41B7-B893-7A786E4E6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299F81-42FF-439A-8AFF-604DE34F0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882692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>
  <p:cSld name="7_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04367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0345F5-EAAB-4F95-B053-6CD13E2BA2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2B76315-663B-4D28-9984-5E93BD0ABD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78E2BE-09AB-419D-9EA0-72C261E7E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C72188-21AB-45DD-B890-1A630DA67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03C495-3A8E-4B05-814A-ACA12DC03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622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D8D3A4-EBE7-4D20-94D1-402B9E275B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532176F-26AD-40BA-B556-905203A019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FD87D3-8001-45B1-9A52-6EDDE9129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6EA255-568D-439A-A3F4-2207B7042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F23881-BEAD-43E3-81ED-BE4952216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9575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4DF357-0B20-4BEF-86CD-7CC234FE91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9DE461B-DA65-4955-996D-43AC80DA37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2AC47FA-6526-4B00-9134-B4C20AA1BB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B7D4E3E-603A-4B23-892C-D536C7F34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589172D-5E80-422D-A465-96418D9F5B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77C3D5E-0DD8-4850-A97D-BC03ED4A3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8909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69A779-EFCF-4F69-8EA3-E658984A0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1054740-F339-4A43-B953-CC01A761BB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54F390C-DA65-4D1C-B9A2-2A04C656D5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2557ECF-DDE2-45BC-B653-32EF7A3163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81BD7C3-C817-4514-99A0-FC0E20C28D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39F8379-D3F9-4005-90BB-47676B5EB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EE6DE3C-1A9F-4EBA-97D7-2E6D3905B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671E008-1CF2-43A4-BF6B-9C1CF42D5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474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F3BD04-7BEE-4096-A768-3CC05CBA4A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B891866-51ED-402E-A77F-C8A6822CC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ECCDACD-19E4-4615-AAD4-A9E78210F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0F10640-65EB-4010-8874-8021CBD11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941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E4045C5-2F3E-4B10-9093-B00409E3A2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285BAC7-36CF-49A7-9EBE-7CDACC62C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7662977-1AE3-428D-BB1A-07EE14E38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5386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99A29F-9225-4381-BF5E-3A2A4E73A3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C2E3E26-167F-4C70-A6F9-AED12432C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627D9A8-30F2-40FD-9CBA-FD206E4771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926ED95-CA2E-4C57-84D9-68C0F6AEB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3DFD55-65D8-49DC-9B47-69B5E7ACC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E0588A9-C93A-431A-9DFB-A11B7DCD2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3092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1E7BCE-CE58-4B52-B1CE-29489B9A1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95541FF-3ABB-422E-B5E2-0ECBC4B4D3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599A6AD-C6BD-4089-9AF3-8AA933448C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239E84C-9BB9-49DB-8673-C78FD2EA2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909014-0EA2-4C56-A151-B19D493FF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A1EC0BF-D11F-42B8-99B5-A966E7874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50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49C5595-A38A-42AD-954F-F8734070C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3279E46-D1AD-4F4C-A134-3E07046905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15D5AF0-FC7D-43B6-82BA-6867E70B52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0ABED6-1DD9-467B-A2EA-09901B38DDA0}" type="datetimeFigureOut">
              <a:rPr kumimoji="1" lang="ja-JP" altLang="en-US" smtClean="0"/>
              <a:t>2025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A9A719-4B66-4EBB-9AFF-E201AA1ED1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9AA0B7-1F9C-4F7B-BD22-01651C0975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FF9F3-C945-4949-982D-087DC12D5B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113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B40352DD-29D7-4726-A0AF-ACC8A2286C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7656109"/>
              </p:ext>
            </p:extLst>
          </p:nvPr>
        </p:nvGraphicFramePr>
        <p:xfrm>
          <a:off x="2855157" y="2100075"/>
          <a:ext cx="6112541" cy="3693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DCF9905-B17F-45C2-923E-B3F0D031F788}"/>
              </a:ext>
            </a:extLst>
          </p:cNvPr>
          <p:cNvSpPr txBox="1"/>
          <p:nvPr/>
        </p:nvSpPr>
        <p:spPr>
          <a:xfrm>
            <a:off x="6935445" y="2100075"/>
            <a:ext cx="111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.6%</a:t>
            </a:r>
          </a:p>
          <a:p>
            <a:pPr algn="ctr"/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167/1,953)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97EB8F5-D621-491A-B150-D71682A6B9DC}"/>
              </a:ext>
            </a:extLst>
          </p:cNvPr>
          <p:cNvSpPr txBox="1"/>
          <p:nvPr/>
        </p:nvSpPr>
        <p:spPr>
          <a:xfrm>
            <a:off x="5578538" y="1180290"/>
            <a:ext cx="1034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0.001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A51D9E4-1F80-4971-81C9-7A723ADFF48A}"/>
              </a:ext>
            </a:extLst>
          </p:cNvPr>
          <p:cNvSpPr txBox="1"/>
          <p:nvPr/>
        </p:nvSpPr>
        <p:spPr>
          <a:xfrm>
            <a:off x="4310718" y="3100700"/>
            <a:ext cx="111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.8</a:t>
            </a:r>
            <a:r>
              <a:rPr kumimoji="1"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</a:p>
          <a:p>
            <a:pPr algn="ctr"/>
            <a:r>
              <a:rPr lang="en-US" altLang="ja-JP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113/1,953)</a:t>
            </a:r>
            <a:endParaRPr kumimoji="1" lang="ja-JP" altLang="en-US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コネクタ: カギ線 6">
            <a:extLst>
              <a:ext uri="{FF2B5EF4-FFF2-40B4-BE49-F238E27FC236}">
                <a16:creationId xmlns:a16="http://schemas.microsoft.com/office/drawing/2014/main" id="{B466F034-7AE1-4D7C-BEB0-9522334060F9}"/>
              </a:ext>
            </a:extLst>
          </p:cNvPr>
          <p:cNvCxnSpPr>
            <a:cxnSpLocks/>
            <a:endCxn id="5" idx="0"/>
          </p:cNvCxnSpPr>
          <p:nvPr/>
        </p:nvCxnSpPr>
        <p:spPr>
          <a:xfrm>
            <a:off x="4868714" y="1539477"/>
            <a:ext cx="2624731" cy="560598"/>
          </a:xfrm>
          <a:prstGeom prst="bentConnector2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7AB2EF8E-422A-423D-98C2-D058171AF5F8}"/>
              </a:ext>
            </a:extLst>
          </p:cNvPr>
          <p:cNvCxnSpPr>
            <a:cxnSpLocks/>
            <a:endCxn id="4" idx="0"/>
          </p:cNvCxnSpPr>
          <p:nvPr/>
        </p:nvCxnSpPr>
        <p:spPr>
          <a:xfrm>
            <a:off x="4868718" y="1543667"/>
            <a:ext cx="0" cy="155703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A893259-15BF-4F97-A9B0-A7C582C5AAB8}"/>
              </a:ext>
            </a:extLst>
          </p:cNvPr>
          <p:cNvSpPr txBox="1"/>
          <p:nvPr/>
        </p:nvSpPr>
        <p:spPr>
          <a:xfrm>
            <a:off x="3156720" y="1819776"/>
            <a:ext cx="4754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%]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E19C80E-689E-47CA-BD1E-96CF17DDE054}"/>
              </a:ext>
            </a:extLst>
          </p:cNvPr>
          <p:cNvSpPr txBox="1"/>
          <p:nvPr/>
        </p:nvSpPr>
        <p:spPr>
          <a:xfrm>
            <a:off x="292116" y="355323"/>
            <a:ext cx="2277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3939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20</Words>
  <Application>Microsoft Office PowerPoint</Application>
  <PresentationFormat>ワイド画面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香菜子</dc:creator>
  <cp:lastModifiedBy>水野香菜子</cp:lastModifiedBy>
  <cp:revision>2</cp:revision>
  <cp:lastPrinted>2025-05-20T08:00:25Z</cp:lastPrinted>
  <dcterms:created xsi:type="dcterms:W3CDTF">2025-04-24T00:29:59Z</dcterms:created>
  <dcterms:modified xsi:type="dcterms:W3CDTF">2025-05-20T08:47:22Z</dcterms:modified>
</cp:coreProperties>
</file>